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7"/>
  </p:notesMasterIdLst>
  <p:sldIdLst>
    <p:sldId id="358" r:id="rId5"/>
    <p:sldId id="357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C80"/>
    <a:srgbClr val="CC0000"/>
    <a:srgbClr val="CC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1" autoAdjust="0"/>
    <p:restoredTop sz="94660"/>
  </p:normalViewPr>
  <p:slideViewPr>
    <p:cSldViewPr snapToGrid="0">
      <p:cViewPr varScale="1">
        <p:scale>
          <a:sx n="65" d="100"/>
          <a:sy n="65" d="100"/>
        </p:scale>
        <p:origin x="1258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38042D-4F60-48E8-BA1F-E861530F9067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235192-B705-4BC1-A5A1-FEA4E1DB5A7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950807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51FD3-97E7-4C23-AE62-5B8596DBF339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313D6-1C4B-4E1A-9A5D-2B32BFFB46D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09921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51FD3-97E7-4C23-AE62-5B8596DBF339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313D6-1C4B-4E1A-9A5D-2B32BFFB46D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04195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51FD3-97E7-4C23-AE62-5B8596DBF339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313D6-1C4B-4E1A-9A5D-2B32BFFB46D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52053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51FD3-97E7-4C23-AE62-5B8596DBF339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313D6-1C4B-4E1A-9A5D-2B32BFFB46D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5039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51FD3-97E7-4C23-AE62-5B8596DBF339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313D6-1C4B-4E1A-9A5D-2B32BFFB46D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47334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51FD3-97E7-4C23-AE62-5B8596DBF339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313D6-1C4B-4E1A-9A5D-2B32BFFB46D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26134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51FD3-97E7-4C23-AE62-5B8596DBF339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313D6-1C4B-4E1A-9A5D-2B32BFFB46D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26825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51FD3-97E7-4C23-AE62-5B8596DBF339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313D6-1C4B-4E1A-9A5D-2B32BFFB46D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250361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51FD3-97E7-4C23-AE62-5B8596DBF339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313D6-1C4B-4E1A-9A5D-2B32BFFB46D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73710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51FD3-97E7-4C23-AE62-5B8596DBF339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313D6-1C4B-4E1A-9A5D-2B32BFFB46D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76759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51FD3-97E7-4C23-AE62-5B8596DBF339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313D6-1C4B-4E1A-9A5D-2B32BFFB46D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78894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951FD3-97E7-4C23-AE62-5B8596DBF339}" type="datetimeFigureOut">
              <a:rPr lang="es-MX" smtClean="0"/>
              <a:t>28/03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3313D6-1C4B-4E1A-9A5D-2B32BFFB46D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11958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o 4">
            <a:extLst>
              <a:ext uri="{FF2B5EF4-FFF2-40B4-BE49-F238E27FC236}">
                <a16:creationId xmlns:a16="http://schemas.microsoft.com/office/drawing/2014/main" id="{4942B21F-6344-4919-B88B-29D592E516EC}"/>
              </a:ext>
            </a:extLst>
          </p:cNvPr>
          <p:cNvGrpSpPr/>
          <p:nvPr/>
        </p:nvGrpSpPr>
        <p:grpSpPr>
          <a:xfrm>
            <a:off x="117328" y="0"/>
            <a:ext cx="8727734" cy="6658708"/>
            <a:chOff x="636607" y="689417"/>
            <a:chExt cx="7454096" cy="5890048"/>
          </a:xfrm>
        </p:grpSpPr>
        <p:pic>
          <p:nvPicPr>
            <p:cNvPr id="2" name="Imagen 1">
              <a:extLst>
                <a:ext uri="{FF2B5EF4-FFF2-40B4-BE49-F238E27FC236}">
                  <a16:creationId xmlns:a16="http://schemas.microsoft.com/office/drawing/2014/main" id="{246BB24A-711D-4B63-B747-5583BD045D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36607" y="689417"/>
              <a:ext cx="7454096" cy="4192929"/>
            </a:xfrm>
            <a:prstGeom prst="rect">
              <a:avLst/>
            </a:prstGeom>
          </p:spPr>
        </p:pic>
        <p:pic>
          <p:nvPicPr>
            <p:cNvPr id="4" name="Imagen 3">
              <a:extLst>
                <a:ext uri="{FF2B5EF4-FFF2-40B4-BE49-F238E27FC236}">
                  <a16:creationId xmlns:a16="http://schemas.microsoft.com/office/drawing/2014/main" id="{3B9E7E4F-0782-426A-9932-6439FA7D8E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4725" b="50000"/>
            <a:stretch/>
          </p:blipFill>
          <p:spPr>
            <a:xfrm>
              <a:off x="756236" y="4711597"/>
              <a:ext cx="7334467" cy="186786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197762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41A59AAD-879A-4A16-A487-F2B1684C9F35}"/>
              </a:ext>
            </a:extLst>
          </p:cNvPr>
          <p:cNvGrpSpPr/>
          <p:nvPr/>
        </p:nvGrpSpPr>
        <p:grpSpPr>
          <a:xfrm>
            <a:off x="81627" y="334330"/>
            <a:ext cx="8980746" cy="4812100"/>
            <a:chOff x="723418" y="439838"/>
            <a:chExt cx="7745370" cy="3866044"/>
          </a:xfrm>
        </p:grpSpPr>
        <p:pic>
          <p:nvPicPr>
            <p:cNvPr id="2" name="Imagen 1">
              <a:extLst>
                <a:ext uri="{FF2B5EF4-FFF2-40B4-BE49-F238E27FC236}">
                  <a16:creationId xmlns:a16="http://schemas.microsoft.com/office/drawing/2014/main" id="{ED58A761-A5FD-44AD-80D0-4D9599A61A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50298" b="4532"/>
            <a:stretch/>
          </p:blipFill>
          <p:spPr>
            <a:xfrm>
              <a:off x="831470" y="439838"/>
              <a:ext cx="7334467" cy="1863523"/>
            </a:xfrm>
            <a:prstGeom prst="rect">
              <a:avLst/>
            </a:prstGeom>
          </p:spPr>
        </p:pic>
        <p:pic>
          <p:nvPicPr>
            <p:cNvPr id="3" name="Imagen 2">
              <a:extLst>
                <a:ext uri="{FF2B5EF4-FFF2-40B4-BE49-F238E27FC236}">
                  <a16:creationId xmlns:a16="http://schemas.microsoft.com/office/drawing/2014/main" id="{162AE134-088E-44F0-853A-AAF7AFD050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4037" b="50000"/>
            <a:stretch/>
          </p:blipFill>
          <p:spPr>
            <a:xfrm>
              <a:off x="723418" y="2303361"/>
              <a:ext cx="7745370" cy="2002521"/>
            </a:xfrm>
            <a:prstGeom prst="rect">
              <a:avLst/>
            </a:prstGeom>
          </p:spPr>
        </p:pic>
      </p:grpSp>
      <p:sp>
        <p:nvSpPr>
          <p:cNvPr id="6" name="Rectángulo 5">
            <a:extLst>
              <a:ext uri="{FF2B5EF4-FFF2-40B4-BE49-F238E27FC236}">
                <a16:creationId xmlns:a16="http://schemas.microsoft.com/office/drawing/2014/main" id="{D9164BA7-E40D-49DA-937E-2EEAE56FE523}"/>
              </a:ext>
            </a:extLst>
          </p:cNvPr>
          <p:cNvSpPr/>
          <p:nvPr/>
        </p:nvSpPr>
        <p:spPr>
          <a:xfrm>
            <a:off x="81627" y="5407211"/>
            <a:ext cx="8980746" cy="13504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MS/MS analysis of compounds most abundant in RHTR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agmentation pattern utilized for putatively identified the compounds most abundant in AE and FF from RHTR respectively, by comparison with reports in plant metabolomics databases with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genesis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I. The inset shows fragmentation of analytical standards used for corroborate the identification.</a:t>
            </a:r>
            <a:endParaRPr lang="es-MX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05770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>
    <DocumentType xmlns="d32f49f5-84c9-4c54-bfc5-52c1fba82207">Presentation</DocumentType>
    <StageName xmlns="d32f49f5-84c9-4c54-bfc5-52c1fba82207" xsi:nil="true"/>
    <DocumentId xmlns="d32f49f5-84c9-4c54-bfc5-52c1fba82207">Presentation 1.PPTX</DocumentId>
    <FileFormat xmlns="d32f49f5-84c9-4c54-bfc5-52c1fba82207">PPTX</FileFormat>
    <TitleName xmlns="d32f49f5-84c9-4c54-bfc5-52c1fba82207">Presentation 1.PPTX</TitleName>
    <IsDeleted xmlns="d32f49f5-84c9-4c54-bfc5-52c1fba82207">false</IsDeleted>
    <Checked_x0020_Out_x0020_To xmlns="d32f49f5-84c9-4c54-bfc5-52c1fba82207">
      <UserInfo>
        <DisplayName/>
        <AccountId xsi:nil="true"/>
        <AccountType/>
      </UserInfo>
    </Checked_x0020_Out_x0020_To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FE52E483303764787951F8FB124494C" ma:contentTypeVersion="7" ma:contentTypeDescription="Create a new document." ma:contentTypeScope="" ma:versionID="2895b95a7eb6ec6058b81558cb90879f">
  <xsd:schema xmlns:xsd="http://www.w3.org/2001/XMLSchema" xmlns:p="http://schemas.microsoft.com/office/2006/metadata/properties" xmlns:ns2="d32f49f5-84c9-4c54-bfc5-52c1fba82207" targetNamespace="http://schemas.microsoft.com/office/2006/metadata/properties" ma:root="true" ma:fieldsID="624482fdad798477c2cf5b15530b80e7" ns2:_="">
    <xsd:import namespace="d32f49f5-84c9-4c54-bfc5-52c1fba82207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d32f49f5-84c9-4c54-bfc5-52c1fba82207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7708CE4E-B1F6-4C46-A6BA-E5E57D1C9339}">
  <ds:schemaRefs>
    <ds:schemaRef ds:uri="http://purl.org/dc/elements/1.1/"/>
    <ds:schemaRef ds:uri="http://www.w3.org/XML/1998/namespace"/>
    <ds:schemaRef ds:uri="http://schemas.microsoft.com/office/2006/documentManagement/types"/>
    <ds:schemaRef ds:uri="http://schemas.microsoft.com/office/2006/metadata/properties"/>
    <ds:schemaRef ds:uri="http://purl.org/dc/dcmitype/"/>
    <ds:schemaRef ds:uri="http://schemas.openxmlformats.org/package/2006/metadata/core-properties"/>
    <ds:schemaRef ds:uri="d32f49f5-84c9-4c54-bfc5-52c1fba82207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6999837B-1A12-45CE-8864-5D928764709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B4E524E-793B-460D-9B41-353AFE43BA6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32f49f5-84c9-4c54-bfc5-52c1fba82207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953</TotalTime>
  <Words>58</Words>
  <Application>Microsoft Office PowerPoint</Application>
  <PresentationFormat>Presentación en pantalla (4:3)</PresentationFormat>
  <Paragraphs>2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is Varela Rodriguez</dc:creator>
  <cp:lastModifiedBy>Luis Varela Rodriguez</cp:lastModifiedBy>
  <cp:revision>431</cp:revision>
  <dcterms:created xsi:type="dcterms:W3CDTF">2016-11-06T02:16:36Z</dcterms:created>
  <dcterms:modified xsi:type="dcterms:W3CDTF">2019-03-29T00:25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FE52E483303764787951F8FB124494C</vt:lpwstr>
  </property>
</Properties>
</file>